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5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22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45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67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171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024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167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5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957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451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016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2C109-8820-42DF-A01D-6BC051E4767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4DBDC-E136-4B6C-9AC1-B304DF780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998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2755" y="0"/>
            <a:ext cx="8980098" cy="6070759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440405" y="6070759"/>
            <a:ext cx="1168591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- The MCC score under different parameters. As the value of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τ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creases from 0.1 to 2.0, the overall trend of MCC score is to increase first and then decrease. When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0.1, MCC score achieves the maximum value at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τ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0.9. When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0.2, MCC score achieves the maximum value at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τ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1.1. When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0.3, MCC score takes the maximum value at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τ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1.0. Under all values of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CC falls into a local minimum when </a:t>
            </a:r>
            <a:r>
              <a:rPr lang="en-US" sz="1200" i="1" dirty="0">
                <a:latin typeface="Cambria Math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τ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0.7.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694114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Calibri</vt:lpstr>
      <vt:lpstr>Calibri Light</vt:lpstr>
      <vt:lpstr>Cambria Math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u-Feng Du</dc:creator>
  <cp:lastModifiedBy>Pu-Feng Du</cp:lastModifiedBy>
  <cp:revision>1</cp:revision>
  <dcterms:created xsi:type="dcterms:W3CDTF">2020-09-30T08:35:06Z</dcterms:created>
  <dcterms:modified xsi:type="dcterms:W3CDTF">2020-09-30T08:35:25Z</dcterms:modified>
</cp:coreProperties>
</file>